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3236913" cy="8229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755800" y="685440"/>
            <a:ext cx="13464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5F7D9A-2B9B-4F84-894D-12BE5A7A2A2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2755800" y="685800"/>
            <a:ext cx="1346400" cy="342900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4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emi-qRT-PCR validation of the expressions of select genes found to be differentially expressed in black (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iR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and brown (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ir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seed coats by microarray analysis. An asterix (*) represents genes located on Chromosome Gm09 of the soybean Glyma1 genome sequence. Genes and corresponding differentially regulated probe sets: </a:t>
            </a:r>
            <a:r>
              <a:rPr b="0" lang="en-CA" sz="1200" spc="-1" strike="noStrike">
                <a:solidFill>
                  <a:srgbClr val="000000"/>
                </a:solidFill>
                <a:latin typeface="Calibri"/>
                <a:ea typeface="Arial"/>
              </a:rPr>
              <a:t>4CL-L, Gma.7423.2.S1_a_at; 4CL-2, Gma.8472.1.S1_at; CHS4 and CHS5, GmaAffx.42116.1.S1_at; LAR1, GmaAffx.34868.1.A1_at; DFR2, GmaAffx.80720.1.S1_at; ANS2/ANS3, Gma.1163.1.S1_at; UGT78K1, Gma.1002.2.S1_at; UGT78K2, GmaAffx.71999.1.S1_at; OMT-like, Gma.9647.1.S1_at; OMT5, GmaAffx.57777.1.S1_at; GST26, GmaAffx.71212.1.A1_at; GST21, Gma.5139.1.S1_at; MYB50, GmaAffx.81605.1.S1_at; MYB159, GmaAffx.39483.1.A1_at; </a:t>
            </a: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C2H2 ZF, Gma.17736.1.S1_at</a:t>
            </a:r>
            <a:r>
              <a:rPr b="0" lang="en-CA" sz="1200" spc="-1" strike="noStrike">
                <a:solidFill>
                  <a:srgbClr val="000000"/>
                </a:solidFill>
                <a:latin typeface="Calibri"/>
                <a:ea typeface="Arial"/>
              </a:rPr>
              <a:t>; WD40, GmaAffx.45454.1.S1_at; SCOF-1, Gma.235.1.S1_at; AP2, GmaAffx.2469.1.S1_at; EF-hand, Gma.15972.1.A1_at; ProtK, GmaAffx.90491.1.A1_s_at; LRR, GmaAffx.12723.1.A1_at; G4DT, Gma.5621.1.S1_at; PAO1-L, Gma.3745.1.S1_at; Am Oxy, Gma.3745.1.S1_at;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CT</a:t>
            </a:r>
            <a:r>
              <a:rPr b="0" lang="en-CA" sz="1200" spc="-1" strike="noStrike">
                <a:solidFill>
                  <a:srgbClr val="000000"/>
                </a:solidFill>
                <a:latin typeface="Calibri"/>
                <a:ea typeface="Arial"/>
              </a:rPr>
              <a:t>, GmaAffx.78720.2.S1_at; PUB22, Gma.4530.1.A1_s_at; 9O12a, Gma.2605.1.S1_at; 9012b, Gma.2605.2.S1_at; Lipase, GmaAffx.90450.1.S1_at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7CB2D2-A147-4AF1-A1F7-A638C649341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41ED7-AA2B-45E6-A08A-5BFEDA556A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2913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62000" y="4756680"/>
            <a:ext cx="2913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96776-D5AA-4A4D-9B5C-1355A8BC3B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654560" y="191916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62000" y="475668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654560" y="475668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4C3CD-F2B3-4229-A749-218CA049BC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9378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46960" y="1919160"/>
            <a:ext cx="9378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132280" y="1919160"/>
            <a:ext cx="9378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62000" y="4756680"/>
            <a:ext cx="9378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146960" y="4756680"/>
            <a:ext cx="9378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132280" y="4756680"/>
            <a:ext cx="93780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CEC41-218B-41A2-A354-C5155047B3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62000" y="1919160"/>
            <a:ext cx="2913120" cy="543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FCF26-D842-41E0-9F22-FC77DA8DDF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291312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C963B-FD61-4DA1-8505-B108113A2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142128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654560" y="1919160"/>
            <a:ext cx="142128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226FA-0D8C-4EC1-A9BA-F20D23E60B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15DA1-0FD9-4414-BF8A-0A383A4D36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62000" y="328680"/>
            <a:ext cx="291312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74975-3D12-4A5A-AA74-FFA95470F6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654560" y="1919160"/>
            <a:ext cx="142128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62000" y="475668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FE28D-75A6-4981-A2E6-EDE61A692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142128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654560" y="191916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654560" y="475668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563B1-89CE-4561-88A6-6F05ACF573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62000" y="297360"/>
            <a:ext cx="291312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62000" y="191916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654560" y="1919160"/>
            <a:ext cx="142128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62000" y="4756680"/>
            <a:ext cx="2913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E00B1-DEB5-48D3-87C1-EBBE809EBD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62000" y="328680"/>
            <a:ext cx="2913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62000" y="1919160"/>
            <a:ext cx="291312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65000"/>
          </a:bodyPr>
          <a:p>
            <a:pPr marL="222840" indent="-2228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482760" indent="-1857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742680" indent="-1483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040040" indent="-1483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1337040" indent="-1483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1337040" indent="-1483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1337040" indent="-1483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61640" y="7626240"/>
            <a:ext cx="75564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106640" y="7626240"/>
            <a:ext cx="102384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319120" y="7626240"/>
            <a:ext cx="75564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FB7334-1620-4657-9711-52D11F64F8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7.png"/><Relationship Id="rId13" Type="http://schemas.openxmlformats.org/officeDocument/2006/relationships/image" Target="../media/image8.png"/><Relationship Id="rId14" Type="http://schemas.openxmlformats.org/officeDocument/2006/relationships/image" Target="../media/image8.png"/><Relationship Id="rId15" Type="http://schemas.openxmlformats.org/officeDocument/2006/relationships/image" Target="../media/image9.png"/><Relationship Id="rId16" Type="http://schemas.openxmlformats.org/officeDocument/2006/relationships/image" Target="../media/image10.png"/><Relationship Id="rId17" Type="http://schemas.openxmlformats.org/officeDocument/2006/relationships/image" Target="../media/image10.png"/><Relationship Id="rId18" Type="http://schemas.openxmlformats.org/officeDocument/2006/relationships/image" Target="../media/image9.png"/><Relationship Id="rId19" Type="http://schemas.openxmlformats.org/officeDocument/2006/relationships/image" Target="../media/image11.png"/><Relationship Id="rId20" Type="http://schemas.openxmlformats.org/officeDocument/2006/relationships/image" Target="../media/image12.png"/><Relationship Id="rId21" Type="http://schemas.openxmlformats.org/officeDocument/2006/relationships/image" Target="../media/image13.png"/><Relationship Id="rId22" Type="http://schemas.openxmlformats.org/officeDocument/2006/relationships/image" Target="../media/image14.png"/><Relationship Id="rId23" Type="http://schemas.openxmlformats.org/officeDocument/2006/relationships/image" Target="../media/image15.png"/><Relationship Id="rId24" Type="http://schemas.openxmlformats.org/officeDocument/2006/relationships/image" Target="../media/image16.png"/><Relationship Id="rId25" Type="http://schemas.openxmlformats.org/officeDocument/2006/relationships/image" Target="../media/image16.png"/><Relationship Id="rId26" Type="http://schemas.openxmlformats.org/officeDocument/2006/relationships/image" Target="../media/image17.png"/><Relationship Id="rId27" Type="http://schemas.openxmlformats.org/officeDocument/2006/relationships/image" Target="../media/image18.png"/><Relationship Id="rId28" Type="http://schemas.openxmlformats.org/officeDocument/2006/relationships/image" Target="../media/image19.png"/><Relationship Id="rId29" Type="http://schemas.openxmlformats.org/officeDocument/2006/relationships/image" Target="../media/image19.png"/><Relationship Id="rId30" Type="http://schemas.openxmlformats.org/officeDocument/2006/relationships/image" Target="../media/image20.png"/><Relationship Id="rId31" Type="http://schemas.openxmlformats.org/officeDocument/2006/relationships/image" Target="../media/image20.png"/><Relationship Id="rId32" Type="http://schemas.openxmlformats.org/officeDocument/2006/relationships/image" Target="../media/image21.png"/><Relationship Id="rId33" Type="http://schemas.openxmlformats.org/officeDocument/2006/relationships/image" Target="../media/image21.png"/><Relationship Id="rId34" Type="http://schemas.openxmlformats.org/officeDocument/2006/relationships/slideLayout" Target="../slideLayouts/slideLayout1.xml"/><Relationship Id="rId3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788"/>
          <p:cNvGrpSpPr/>
          <p:nvPr/>
        </p:nvGrpSpPr>
        <p:grpSpPr>
          <a:xfrm>
            <a:off x="457200" y="71280"/>
            <a:ext cx="2367000" cy="7813800"/>
            <a:chOff x="457200" y="71280"/>
            <a:chExt cx="2367000" cy="7813800"/>
          </a:xfrm>
        </p:grpSpPr>
        <p:pic>
          <p:nvPicPr>
            <p:cNvPr id="49" name="Picture 12" descr="Semi-qRT-PCR (ANS23 AO,, i38 ir 300mg SC) Aug31 10 white.tif"/>
            <p:cNvPicPr/>
            <p:nvPr/>
          </p:nvPicPr>
          <p:blipFill>
            <a:blip r:embed="rId1"/>
            <a:srcRect l="47919" t="59203" r="14945" b="33815"/>
            <a:stretch/>
          </p:blipFill>
          <p:spPr>
            <a:xfrm>
              <a:off x="1171080" y="6069240"/>
              <a:ext cx="1575360" cy="22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3" descr="Semi-qRT-PCR (PEPC MYB159,, i38 ir 300mg SC) Aug28 10 WHITE.tif"/>
            <p:cNvPicPr/>
            <p:nvPr/>
          </p:nvPicPr>
          <p:blipFill>
            <a:blip r:embed="rId2">
              <a:lum bright="10000"/>
            </a:blip>
            <a:srcRect l="16712" t="60629" r="43886" b="32289"/>
            <a:stretch/>
          </p:blipFill>
          <p:spPr>
            <a:xfrm>
              <a:off x="1148760" y="7609320"/>
              <a:ext cx="1648440" cy="22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6" descr="Semi-qRT-PCR (PEPC MYB159,, i38 ir 300mg SC) Aug28 10 WHITE.tif"/>
            <p:cNvPicPr/>
            <p:nvPr/>
          </p:nvPicPr>
          <p:blipFill>
            <a:blip r:embed="rId3">
              <a:lum bright="22000"/>
            </a:blip>
            <a:srcRect l="50314" t="51996" r="9041" b="41391"/>
            <a:stretch/>
          </p:blipFill>
          <p:spPr>
            <a:xfrm>
              <a:off x="1163160" y="4073400"/>
              <a:ext cx="1527840" cy="21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0" descr="Semi-qRT-PCR (ANS23 AO,, i38 ir 300mg SC) Aug31 10 white.tif"/>
            <p:cNvPicPr/>
            <p:nvPr/>
          </p:nvPicPr>
          <p:blipFill>
            <a:blip r:embed="rId4"/>
            <a:srcRect l="12101" t="58415" r="50432" b="34616"/>
            <a:stretch/>
          </p:blipFill>
          <p:spPr>
            <a:xfrm>
              <a:off x="1150560" y="2054160"/>
              <a:ext cx="1565640" cy="22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5" descr="Semi-qRT-PCR (AP2 LIPASE,, i38 ir 300mg SC) Sept1 10 white.tif"/>
            <p:cNvPicPr/>
            <p:nvPr/>
          </p:nvPicPr>
          <p:blipFill>
            <a:blip r:embed="rId5"/>
            <a:srcRect l="15620" t="30268" r="47697" b="62882"/>
            <a:stretch/>
          </p:blipFill>
          <p:spPr>
            <a:xfrm>
              <a:off x="1150560" y="4951440"/>
              <a:ext cx="1572120" cy="21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6" descr="Semi-qRT-PCR (AP2 LIPASE,, i38 ir 300mg SC) Sept1 10 white.tif"/>
            <p:cNvPicPr/>
            <p:nvPr/>
          </p:nvPicPr>
          <p:blipFill>
            <a:blip r:embed="rId6"/>
            <a:srcRect l="50645" t="31788" r="12220" b="61361"/>
            <a:stretch/>
          </p:blipFill>
          <p:spPr>
            <a:xfrm>
              <a:off x="1193400" y="7382160"/>
              <a:ext cx="1553040" cy="21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20" descr="Semi-qRT-PCR (C2H2_ZF 9012b,, i38 ir 300mgSC) Aug30 10 WHITE.tif"/>
            <p:cNvPicPr/>
            <p:nvPr/>
          </p:nvPicPr>
          <p:blipFill>
            <a:blip r:embed="rId7">
              <a:lum bright="10000"/>
            </a:blip>
            <a:srcRect l="46956" t="32514" r="12673" b="60761"/>
            <a:stretch/>
          </p:blipFill>
          <p:spPr>
            <a:xfrm>
              <a:off x="1109160" y="7160040"/>
              <a:ext cx="161964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23" descr="Semi-qRT-PCR (CHS4 CHS5,, i38 ir 300mg SC) Sept2 10 white.tif"/>
            <p:cNvPicPr/>
            <p:nvPr/>
          </p:nvPicPr>
          <p:blipFill>
            <a:blip r:embed="rId8">
              <a:lum contrast="40000"/>
            </a:blip>
            <a:srcRect l="12716" t="14389" r="49606" b="78760"/>
            <a:stretch/>
          </p:blipFill>
          <p:spPr>
            <a:xfrm>
              <a:off x="1156680" y="902880"/>
              <a:ext cx="1580040" cy="21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25" descr="Semi-qRT-PCR (CHS4 CHS5,, i38 ir 300mg SC) Sept2 10 white.tif"/>
            <p:cNvPicPr/>
            <p:nvPr/>
          </p:nvPicPr>
          <p:blipFill>
            <a:blip r:embed="rId9">
              <a:lum contrast="40000"/>
            </a:blip>
            <a:srcRect l="46828" t="15434" r="14397" b="77596"/>
            <a:stretch/>
          </p:blipFill>
          <p:spPr>
            <a:xfrm>
              <a:off x="1129680" y="1126800"/>
              <a:ext cx="1624680" cy="22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28" descr="Semi-qRT-PCR (CHS78,, i38 ir 300mg SC) Sept2 10 white.tif"/>
            <p:cNvPicPr/>
            <p:nvPr/>
          </p:nvPicPr>
          <p:blipFill>
            <a:blip r:embed="rId10"/>
            <a:srcRect l="28789" t="22929" r="33348" b="69857"/>
            <a:stretch/>
          </p:blipFill>
          <p:spPr>
            <a:xfrm>
              <a:off x="1175760" y="1357200"/>
              <a:ext cx="1581840" cy="22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30" descr="Semi-qRT-PCR (DFR2 GST1,, i38 ir 300mg SC) Sept1 10 white.tif"/>
            <p:cNvPicPr/>
            <p:nvPr/>
          </p:nvPicPr>
          <p:blipFill>
            <a:blip r:embed="rId11"/>
            <a:srcRect l="13169" t="59253" r="49332" b="33771"/>
            <a:stretch/>
          </p:blipFill>
          <p:spPr>
            <a:xfrm>
              <a:off x="1156680" y="1825560"/>
              <a:ext cx="1570680" cy="225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31" descr="Semi-qRT-PCR (DFR2 GST1,, i38 ir 300mg SC) Sept1 10 white.tif"/>
            <p:cNvPicPr/>
            <p:nvPr/>
          </p:nvPicPr>
          <p:blipFill>
            <a:blip r:embed="rId12"/>
            <a:srcRect l="47556" t="55524" r="13674" b="37625"/>
            <a:stretch/>
          </p:blipFill>
          <p:spPr>
            <a:xfrm>
              <a:off x="1136160" y="3398760"/>
              <a:ext cx="1621440" cy="21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34" descr="Semi-qRT-PCR (EF-hand 4CL2,, i38 ir 300mg SC) Aug28 10 White.tif"/>
            <p:cNvPicPr/>
            <p:nvPr/>
          </p:nvPicPr>
          <p:blipFill>
            <a:blip r:embed="rId13"/>
            <a:srcRect l="16508" t="31338" r="47565" b="60579"/>
            <a:stretch/>
          </p:blipFill>
          <p:spPr>
            <a:xfrm>
              <a:off x="1202760" y="5173920"/>
              <a:ext cx="1503720" cy="225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35" descr="Semi-qRT-PCR (EF-hand 4CL2,, i38 ir 300mg SC) Aug28 10 White.tif"/>
            <p:cNvPicPr/>
            <p:nvPr/>
          </p:nvPicPr>
          <p:blipFill>
            <a:blip r:embed="rId14"/>
            <a:srcRect l="50668" t="31338" r="11568" b="60579"/>
            <a:stretch/>
          </p:blipFill>
          <p:spPr>
            <a:xfrm>
              <a:off x="1199520" y="669600"/>
              <a:ext cx="1565640" cy="225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39" descr="Semi-qRT-PCR (MYB50 G4DT,, i38 ir 300mgSC) Aug30 WHITE.tif"/>
            <p:cNvPicPr/>
            <p:nvPr/>
          </p:nvPicPr>
          <p:blipFill>
            <a:blip r:embed="rId15"/>
            <a:srcRect l="45019" t="48868" r="16244" b="44225"/>
            <a:stretch/>
          </p:blipFill>
          <p:spPr>
            <a:xfrm>
              <a:off x="1193400" y="3843360"/>
              <a:ext cx="1543680" cy="22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42" descr="Semi-qRT-PCR (LAR1 ANR1,, i38 ir 300mg SC) Sept1 10 white.tif"/>
            <p:cNvPicPr/>
            <p:nvPr/>
          </p:nvPicPr>
          <p:blipFill>
            <a:blip r:embed="rId16"/>
            <a:srcRect l="10085" t="22279" r="52156" b="70702"/>
            <a:stretch/>
          </p:blipFill>
          <p:spPr>
            <a:xfrm>
              <a:off x="1185480" y="1589040"/>
              <a:ext cx="1580040" cy="22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43" descr="Semi-qRT-PCR (LAR1 ANR1,, i38 ir 300mg SC) Sept1 10 white.tif"/>
            <p:cNvPicPr/>
            <p:nvPr/>
          </p:nvPicPr>
          <p:blipFill>
            <a:blip r:embed="rId17"/>
            <a:srcRect l="43408" t="21928" r="16971" b="70277"/>
            <a:stretch/>
          </p:blipFill>
          <p:spPr>
            <a:xfrm>
              <a:off x="1132920" y="2273040"/>
              <a:ext cx="1659600" cy="250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47" descr="Semi-qRT-PCR (MYB50 G4DT,, i38 ir 300mgSC) Aug30 WHITE.tif"/>
            <p:cNvPicPr/>
            <p:nvPr/>
          </p:nvPicPr>
          <p:blipFill>
            <a:blip r:embed="rId18"/>
            <a:srcRect l="46106" t="48993" r="15979" b="44238"/>
            <a:stretch/>
          </p:blipFill>
          <p:spPr>
            <a:xfrm>
              <a:off x="1199520" y="5851800"/>
              <a:ext cx="1586520" cy="21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50" descr="Semi-qRT-PCR (OMT2 OMT,, i38 ir 300mgSC) Aug30 Pic2 WHITE.tif"/>
            <p:cNvPicPr/>
            <p:nvPr/>
          </p:nvPicPr>
          <p:blipFill>
            <a:blip r:embed="rId19"/>
            <a:srcRect l="50763" t="43550" r="10349" b="50050"/>
            <a:stretch/>
          </p:blipFill>
          <p:spPr>
            <a:xfrm>
              <a:off x="1193400" y="2957400"/>
              <a:ext cx="1626120" cy="21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51" descr="Semi-qRT-PCR (OMT2 OMT,, i38 ir 300mgSC) Aug30 WHITE.tif"/>
            <p:cNvPicPr/>
            <p:nvPr/>
          </p:nvPicPr>
          <p:blipFill>
            <a:blip r:embed="rId20"/>
            <a:srcRect l="15431" t="42705" r="45865" b="50651"/>
            <a:stretch/>
          </p:blipFill>
          <p:spPr>
            <a:xfrm>
              <a:off x="1167840" y="3184560"/>
              <a:ext cx="1565640" cy="21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54" descr="Semi-qRT-PCR (PECTIN OXY,, i38 ir 300mg SC) Aug31 10.1sc WHITE.tif"/>
            <p:cNvPicPr/>
            <p:nvPr/>
          </p:nvPicPr>
          <p:blipFill>
            <a:blip r:embed="rId21">
              <a:lum bright="20000"/>
            </a:blip>
            <a:srcRect l="16981" t="27221" r="44400" b="66491"/>
            <a:stretch/>
          </p:blipFill>
          <p:spPr>
            <a:xfrm>
              <a:off x="1190160" y="6507360"/>
              <a:ext cx="1616760" cy="204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55" descr="Semi-qRT-PCR (PECTIN OXY,, i38 ir 300mg SC) Aug31 10.1sc WHITE.tif"/>
            <p:cNvPicPr/>
            <p:nvPr/>
          </p:nvPicPr>
          <p:blipFill>
            <a:blip r:embed="rId22"/>
            <a:srcRect l="51405" t="27221" r="10255" b="66491"/>
            <a:stretch/>
          </p:blipFill>
          <p:spPr>
            <a:xfrm>
              <a:off x="1172520" y="6299280"/>
              <a:ext cx="1607040" cy="201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58" descr="Semi-qRT-PCR (ProtKinase WRKY56 ,, i38 ir 300mgSC) Aug30 WHITE.tif"/>
            <p:cNvPicPr/>
            <p:nvPr/>
          </p:nvPicPr>
          <p:blipFill>
            <a:blip r:embed="rId23">
              <a:lum bright="20000"/>
            </a:blip>
            <a:srcRect l="12966" t="37757" r="48420" b="55249"/>
            <a:stretch/>
          </p:blipFill>
          <p:spPr>
            <a:xfrm>
              <a:off x="1172520" y="5396040"/>
              <a:ext cx="1616760" cy="22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61" descr="Semi-qRT-PCR (RingFing 9012a,, i38 ir 300mgSC) Aug30 10 WHITE.tif"/>
            <p:cNvPicPr/>
            <p:nvPr/>
          </p:nvPicPr>
          <p:blipFill>
            <a:blip r:embed="rId24"/>
            <a:srcRect l="12597" t="42461" r="50791" b="50776"/>
            <a:stretch/>
          </p:blipFill>
          <p:spPr>
            <a:xfrm>
              <a:off x="1177560" y="6718680"/>
              <a:ext cx="155628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62" descr="Semi-qRT-PCR (RingFing 9012a,, i38 ir 300mgSC) Aug30 10 WHITE.tif"/>
            <p:cNvPicPr/>
            <p:nvPr/>
          </p:nvPicPr>
          <p:blipFill>
            <a:blip r:embed="rId25"/>
            <a:srcRect l="47570" t="40165" r="14874" b="50776"/>
            <a:stretch/>
          </p:blipFill>
          <p:spPr>
            <a:xfrm>
              <a:off x="1202760" y="6940800"/>
              <a:ext cx="1572120" cy="21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65" descr="Semi-qRT-PCR (SCOFTF GST21,, i38 ir 300mg SC) Aug28 10 White.tif"/>
            <p:cNvPicPr/>
            <p:nvPr/>
          </p:nvPicPr>
          <p:blipFill>
            <a:blip r:embed="rId26"/>
            <a:srcRect l="17349" t="39677" r="42757" b="52321"/>
            <a:stretch/>
          </p:blipFill>
          <p:spPr>
            <a:xfrm>
              <a:off x="1206000" y="4726080"/>
              <a:ext cx="1618200" cy="21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66" descr="Semi-qRT-PCR (SCOFTF GST21,, i38 ir 300mg SC) Aug28 10 White.tif"/>
            <p:cNvPicPr/>
            <p:nvPr/>
          </p:nvPicPr>
          <p:blipFill>
            <a:blip r:embed="rId27"/>
            <a:srcRect l="53139" t="39677" r="8162" b="52321"/>
            <a:stretch/>
          </p:blipFill>
          <p:spPr>
            <a:xfrm>
              <a:off x="1182240" y="3621240"/>
              <a:ext cx="1618200" cy="21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69" descr="Semi-qRT-PCR (UGT78K1 UGT78K2,, i38 ir 300mg SC) Aug31 10 white.tif"/>
            <p:cNvPicPr/>
            <p:nvPr/>
          </p:nvPicPr>
          <p:blipFill>
            <a:blip r:embed="rId28">
              <a:lum bright="20000"/>
            </a:blip>
            <a:srcRect l="13330" t="72573" r="49516" b="20420"/>
            <a:stretch/>
          </p:blipFill>
          <p:spPr>
            <a:xfrm>
              <a:off x="1175760" y="2517480"/>
              <a:ext cx="1553040" cy="21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70" descr="Semi-qRT-PCR (UGT78K1 UGT78K2,, i38 ir 300mg SC) Aug31 10 white.tif"/>
            <p:cNvPicPr/>
            <p:nvPr/>
          </p:nvPicPr>
          <p:blipFill>
            <a:blip r:embed="rId29">
              <a:lum bright="20000"/>
            </a:blip>
            <a:srcRect l="48453" t="74869" r="12541" b="18062"/>
            <a:stretch/>
          </p:blipFill>
          <p:spPr>
            <a:xfrm>
              <a:off x="1183680" y="2732040"/>
              <a:ext cx="1506960" cy="230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73" descr="Semi-qRT-PCR (WD40 LRR,, i38 ir 300mg SC) Aug31 10 WHITE.tif"/>
            <p:cNvPicPr/>
            <p:nvPr/>
          </p:nvPicPr>
          <p:blipFill>
            <a:blip r:embed="rId30"/>
            <a:srcRect l="16192" t="35679" r="46597" b="57664"/>
            <a:stretch/>
          </p:blipFill>
          <p:spPr>
            <a:xfrm>
              <a:off x="1177560" y="4503960"/>
              <a:ext cx="153576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74" descr="Semi-qRT-PCR (WD40 LRR,, i38 ir 300mg SC) Aug31 10 WHITE.tif"/>
            <p:cNvPicPr/>
            <p:nvPr/>
          </p:nvPicPr>
          <p:blipFill>
            <a:blip r:embed="rId31"/>
            <a:srcRect l="51160" t="33996" r="11809" b="59240"/>
            <a:stretch/>
          </p:blipFill>
          <p:spPr>
            <a:xfrm>
              <a:off x="1179000" y="5624640"/>
              <a:ext cx="1551600" cy="21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78" descr="Semi-qRT-PCR (ZincFing 4CL,, i38 ir 300mgSC) Aug30 10 WHITE.tif"/>
            <p:cNvPicPr/>
            <p:nvPr/>
          </p:nvPicPr>
          <p:blipFill>
            <a:blip r:embed="rId32">
              <a:lum bright="20000"/>
            </a:blip>
            <a:srcRect l="14241" t="33390" r="48330" b="59966"/>
            <a:stretch/>
          </p:blipFill>
          <p:spPr>
            <a:xfrm>
              <a:off x="1175760" y="4291200"/>
              <a:ext cx="1564200" cy="20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79" descr="Semi-qRT-PCR (ZincFing 4CL,, i38 ir 300mgSC) Aug30 10 WHITE.tif"/>
            <p:cNvPicPr/>
            <p:nvPr/>
          </p:nvPicPr>
          <p:blipFill>
            <a:blip r:embed="rId33">
              <a:lum bright="20000"/>
            </a:blip>
            <a:srcRect l="47844" t="33390" r="13637" b="59966"/>
            <a:stretch/>
          </p:blipFill>
          <p:spPr>
            <a:xfrm>
              <a:off x="1150560" y="447480"/>
              <a:ext cx="1592640" cy="214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Rectangle 79"/>
            <p:cNvSpPr/>
            <p:nvPr/>
          </p:nvSpPr>
          <p:spPr>
            <a:xfrm>
              <a:off x="2691000" y="187560"/>
              <a:ext cx="133200" cy="7666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01960" rIns="201960" tIns="100800" bIns="100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80"/>
            <p:cNvSpPr/>
            <p:nvPr/>
          </p:nvSpPr>
          <p:spPr>
            <a:xfrm>
              <a:off x="1056600" y="205560"/>
              <a:ext cx="149040" cy="763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01960" rIns="201960" tIns="100800" bIns="100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4"/>
            <p:cNvSpPr/>
            <p:nvPr/>
          </p:nvSpPr>
          <p:spPr>
            <a:xfrm>
              <a:off x="734400" y="7561440"/>
              <a:ext cx="10177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13"/>
            <p:cNvSpPr/>
            <p:nvPr/>
          </p:nvSpPr>
          <p:spPr>
            <a:xfrm>
              <a:off x="457200" y="1996920"/>
              <a:ext cx="160560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S2/ANS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26"/>
            <p:cNvSpPr/>
            <p:nvPr/>
          </p:nvSpPr>
          <p:spPr>
            <a:xfrm>
              <a:off x="710640" y="848880"/>
              <a:ext cx="119268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HS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27"/>
            <p:cNvSpPr/>
            <p:nvPr/>
          </p:nvSpPr>
          <p:spPr>
            <a:xfrm>
              <a:off x="715320" y="1080720"/>
              <a:ext cx="1400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HS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29"/>
            <p:cNvSpPr/>
            <p:nvPr/>
          </p:nvSpPr>
          <p:spPr>
            <a:xfrm>
              <a:off x="468360" y="1312560"/>
              <a:ext cx="1722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HS7/CHS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32"/>
            <p:cNvSpPr/>
            <p:nvPr/>
          </p:nvSpPr>
          <p:spPr>
            <a:xfrm>
              <a:off x="721800" y="178272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F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33"/>
            <p:cNvSpPr/>
            <p:nvPr/>
          </p:nvSpPr>
          <p:spPr>
            <a:xfrm>
              <a:off x="671400" y="334656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ST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37"/>
            <p:cNvSpPr/>
            <p:nvPr/>
          </p:nvSpPr>
          <p:spPr>
            <a:xfrm>
              <a:off x="699480" y="61740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CL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44"/>
            <p:cNvSpPr/>
            <p:nvPr/>
          </p:nvSpPr>
          <p:spPr>
            <a:xfrm>
              <a:off x="724320" y="154116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A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45"/>
            <p:cNvSpPr/>
            <p:nvPr/>
          </p:nvSpPr>
          <p:spPr>
            <a:xfrm>
              <a:off x="703440" y="223668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49"/>
            <p:cNvSpPr/>
            <p:nvPr/>
          </p:nvSpPr>
          <p:spPr>
            <a:xfrm>
              <a:off x="712440" y="579780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4D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52"/>
            <p:cNvSpPr/>
            <p:nvPr/>
          </p:nvSpPr>
          <p:spPr>
            <a:xfrm>
              <a:off x="554040" y="290520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OMT-lik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53"/>
            <p:cNvSpPr/>
            <p:nvPr/>
          </p:nvSpPr>
          <p:spPr>
            <a:xfrm>
              <a:off x="678960" y="3127320"/>
              <a:ext cx="134820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OMT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68"/>
            <p:cNvSpPr/>
            <p:nvPr/>
          </p:nvSpPr>
          <p:spPr>
            <a:xfrm>
              <a:off x="667440" y="357192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ST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71"/>
            <p:cNvSpPr/>
            <p:nvPr/>
          </p:nvSpPr>
          <p:spPr>
            <a:xfrm>
              <a:off x="549360" y="246060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GT78K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72"/>
            <p:cNvSpPr/>
            <p:nvPr/>
          </p:nvSpPr>
          <p:spPr>
            <a:xfrm>
              <a:off x="548280" y="268272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GT78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81"/>
            <p:cNvSpPr/>
            <p:nvPr/>
          </p:nvSpPr>
          <p:spPr>
            <a:xfrm>
              <a:off x="700920" y="39492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CL-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7"/>
            <p:cNvSpPr/>
            <p:nvPr/>
          </p:nvSpPr>
          <p:spPr>
            <a:xfrm>
              <a:off x="592920" y="4014720"/>
              <a:ext cx="132120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YB15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14"/>
            <p:cNvSpPr/>
            <p:nvPr/>
          </p:nvSpPr>
          <p:spPr>
            <a:xfrm>
              <a:off x="640440" y="6021720"/>
              <a:ext cx="1481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AO1-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17"/>
            <p:cNvSpPr/>
            <p:nvPr/>
          </p:nvSpPr>
          <p:spPr>
            <a:xfrm>
              <a:off x="775080" y="4896000"/>
              <a:ext cx="93204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18"/>
            <p:cNvSpPr/>
            <p:nvPr/>
          </p:nvSpPr>
          <p:spPr>
            <a:xfrm>
              <a:off x="678600" y="7332840"/>
              <a:ext cx="134820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i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22"/>
            <p:cNvSpPr/>
            <p:nvPr/>
          </p:nvSpPr>
          <p:spPr>
            <a:xfrm>
              <a:off x="640800" y="7112160"/>
              <a:ext cx="119268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9012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36"/>
            <p:cNvSpPr/>
            <p:nvPr/>
          </p:nvSpPr>
          <p:spPr>
            <a:xfrm>
              <a:off x="599760" y="512460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F-han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41"/>
            <p:cNvSpPr/>
            <p:nvPr/>
          </p:nvSpPr>
          <p:spPr>
            <a:xfrm>
              <a:off x="646560" y="379584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YB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56"/>
            <p:cNvSpPr/>
            <p:nvPr/>
          </p:nvSpPr>
          <p:spPr>
            <a:xfrm>
              <a:off x="733680" y="6444000"/>
              <a:ext cx="89388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*PC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57"/>
            <p:cNvSpPr/>
            <p:nvPr/>
          </p:nvSpPr>
          <p:spPr>
            <a:xfrm>
              <a:off x="575640" y="623448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Am Ox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59"/>
            <p:cNvSpPr/>
            <p:nvPr/>
          </p:nvSpPr>
          <p:spPr>
            <a:xfrm>
              <a:off x="660960" y="5345280"/>
              <a:ext cx="151164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Prot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63"/>
            <p:cNvSpPr/>
            <p:nvPr/>
          </p:nvSpPr>
          <p:spPr>
            <a:xfrm>
              <a:off x="668520" y="666144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UB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64"/>
            <p:cNvSpPr/>
            <p:nvPr/>
          </p:nvSpPr>
          <p:spPr>
            <a:xfrm>
              <a:off x="631440" y="689004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9O1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67"/>
            <p:cNvSpPr/>
            <p:nvPr/>
          </p:nvSpPr>
          <p:spPr>
            <a:xfrm>
              <a:off x="645480" y="4664160"/>
              <a:ext cx="13449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COF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75"/>
            <p:cNvSpPr/>
            <p:nvPr/>
          </p:nvSpPr>
          <p:spPr>
            <a:xfrm>
              <a:off x="632880" y="445284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WD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76"/>
            <p:cNvSpPr/>
            <p:nvPr/>
          </p:nvSpPr>
          <p:spPr>
            <a:xfrm>
              <a:off x="738720" y="556920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*LR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80"/>
            <p:cNvSpPr/>
            <p:nvPr/>
          </p:nvSpPr>
          <p:spPr>
            <a:xfrm>
              <a:off x="609480" y="4232160"/>
              <a:ext cx="13467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Calibri"/>
                </a:rPr>
                <a:t>C2H2 Z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320"/>
            <p:cNvSpPr/>
            <p:nvPr/>
          </p:nvSpPr>
          <p:spPr>
            <a:xfrm>
              <a:off x="1179000" y="66168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321"/>
            <p:cNvSpPr/>
            <p:nvPr/>
          </p:nvSpPr>
          <p:spPr>
            <a:xfrm>
              <a:off x="1193400" y="89820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322"/>
            <p:cNvSpPr/>
            <p:nvPr/>
          </p:nvSpPr>
          <p:spPr>
            <a:xfrm>
              <a:off x="1179000" y="112356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323"/>
            <p:cNvSpPr/>
            <p:nvPr/>
          </p:nvSpPr>
          <p:spPr>
            <a:xfrm>
              <a:off x="1175760" y="135396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324"/>
            <p:cNvSpPr/>
            <p:nvPr/>
          </p:nvSpPr>
          <p:spPr>
            <a:xfrm>
              <a:off x="1167840" y="158724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325"/>
            <p:cNvSpPr/>
            <p:nvPr/>
          </p:nvSpPr>
          <p:spPr>
            <a:xfrm>
              <a:off x="1182240" y="181908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326"/>
            <p:cNvSpPr/>
            <p:nvPr/>
          </p:nvSpPr>
          <p:spPr>
            <a:xfrm>
              <a:off x="1177560" y="205092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327"/>
            <p:cNvSpPr/>
            <p:nvPr/>
          </p:nvSpPr>
          <p:spPr>
            <a:xfrm>
              <a:off x="1164600" y="227952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328"/>
            <p:cNvSpPr/>
            <p:nvPr/>
          </p:nvSpPr>
          <p:spPr>
            <a:xfrm>
              <a:off x="1201320" y="251280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329"/>
            <p:cNvSpPr/>
            <p:nvPr/>
          </p:nvSpPr>
          <p:spPr>
            <a:xfrm>
              <a:off x="1186920" y="272880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330"/>
            <p:cNvSpPr/>
            <p:nvPr/>
          </p:nvSpPr>
          <p:spPr>
            <a:xfrm>
              <a:off x="1164600" y="295884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331"/>
            <p:cNvSpPr/>
            <p:nvPr/>
          </p:nvSpPr>
          <p:spPr>
            <a:xfrm>
              <a:off x="1198080" y="317988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332"/>
            <p:cNvSpPr/>
            <p:nvPr/>
          </p:nvSpPr>
          <p:spPr>
            <a:xfrm>
              <a:off x="1201320" y="339552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333"/>
            <p:cNvSpPr/>
            <p:nvPr/>
          </p:nvSpPr>
          <p:spPr>
            <a:xfrm>
              <a:off x="1204560" y="361944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334"/>
            <p:cNvSpPr/>
            <p:nvPr/>
          </p:nvSpPr>
          <p:spPr>
            <a:xfrm>
              <a:off x="1182240" y="384192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335"/>
            <p:cNvSpPr/>
            <p:nvPr/>
          </p:nvSpPr>
          <p:spPr>
            <a:xfrm>
              <a:off x="1193400" y="407052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336"/>
            <p:cNvSpPr/>
            <p:nvPr/>
          </p:nvSpPr>
          <p:spPr>
            <a:xfrm>
              <a:off x="1164600" y="428616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337"/>
            <p:cNvSpPr/>
            <p:nvPr/>
          </p:nvSpPr>
          <p:spPr>
            <a:xfrm>
              <a:off x="1166400" y="450072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338"/>
            <p:cNvSpPr/>
            <p:nvPr/>
          </p:nvSpPr>
          <p:spPr>
            <a:xfrm>
              <a:off x="1172520" y="472284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339"/>
            <p:cNvSpPr/>
            <p:nvPr/>
          </p:nvSpPr>
          <p:spPr>
            <a:xfrm>
              <a:off x="1182240" y="494820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340"/>
            <p:cNvSpPr/>
            <p:nvPr/>
          </p:nvSpPr>
          <p:spPr>
            <a:xfrm>
              <a:off x="1167840" y="516888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341"/>
            <p:cNvSpPr/>
            <p:nvPr/>
          </p:nvSpPr>
          <p:spPr>
            <a:xfrm>
              <a:off x="1174320" y="540396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342"/>
            <p:cNvSpPr/>
            <p:nvPr/>
          </p:nvSpPr>
          <p:spPr>
            <a:xfrm>
              <a:off x="1177560" y="562140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343"/>
            <p:cNvSpPr/>
            <p:nvPr/>
          </p:nvSpPr>
          <p:spPr>
            <a:xfrm>
              <a:off x="1166400" y="584712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344"/>
            <p:cNvSpPr/>
            <p:nvPr/>
          </p:nvSpPr>
          <p:spPr>
            <a:xfrm>
              <a:off x="1172520" y="607392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345"/>
            <p:cNvSpPr/>
            <p:nvPr/>
          </p:nvSpPr>
          <p:spPr>
            <a:xfrm>
              <a:off x="1167840" y="629460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346"/>
            <p:cNvSpPr/>
            <p:nvPr/>
          </p:nvSpPr>
          <p:spPr>
            <a:xfrm>
              <a:off x="1172520" y="650268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347"/>
            <p:cNvSpPr/>
            <p:nvPr/>
          </p:nvSpPr>
          <p:spPr>
            <a:xfrm>
              <a:off x="1182240" y="671364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348"/>
            <p:cNvSpPr/>
            <p:nvPr/>
          </p:nvSpPr>
          <p:spPr>
            <a:xfrm>
              <a:off x="1167840" y="693612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349"/>
            <p:cNvSpPr/>
            <p:nvPr/>
          </p:nvSpPr>
          <p:spPr>
            <a:xfrm>
              <a:off x="1166400" y="715680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350"/>
            <p:cNvSpPr/>
            <p:nvPr/>
          </p:nvSpPr>
          <p:spPr>
            <a:xfrm>
              <a:off x="1175760" y="7378920"/>
              <a:ext cx="152928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351"/>
            <p:cNvSpPr/>
            <p:nvPr/>
          </p:nvSpPr>
          <p:spPr>
            <a:xfrm>
              <a:off x="1163160" y="7606080"/>
              <a:ext cx="15278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Box 81"/>
            <p:cNvSpPr/>
            <p:nvPr/>
          </p:nvSpPr>
          <p:spPr>
            <a:xfrm>
              <a:off x="1157760" y="213840"/>
              <a:ext cx="411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Box 81"/>
            <p:cNvSpPr/>
            <p:nvPr/>
          </p:nvSpPr>
          <p:spPr>
            <a:xfrm>
              <a:off x="1304280" y="213840"/>
              <a:ext cx="573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+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81"/>
            <p:cNvSpPr/>
            <p:nvPr/>
          </p:nvSpPr>
          <p:spPr>
            <a:xfrm>
              <a:off x="1545840" y="213840"/>
              <a:ext cx="573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+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360"/>
            <p:cNvSpPr/>
            <p:nvPr/>
          </p:nvSpPr>
          <p:spPr>
            <a:xfrm>
              <a:off x="1233000" y="306000"/>
              <a:ext cx="69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Box 81"/>
            <p:cNvSpPr/>
            <p:nvPr/>
          </p:nvSpPr>
          <p:spPr>
            <a:xfrm>
              <a:off x="1854720" y="213840"/>
              <a:ext cx="411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Box 81"/>
            <p:cNvSpPr/>
            <p:nvPr/>
          </p:nvSpPr>
          <p:spPr>
            <a:xfrm>
              <a:off x="2001600" y="213840"/>
              <a:ext cx="573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+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81"/>
            <p:cNvSpPr/>
            <p:nvPr/>
          </p:nvSpPr>
          <p:spPr>
            <a:xfrm>
              <a:off x="2243160" y="213840"/>
              <a:ext cx="573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+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364"/>
            <p:cNvSpPr/>
            <p:nvPr/>
          </p:nvSpPr>
          <p:spPr>
            <a:xfrm>
              <a:off x="1969920" y="306000"/>
              <a:ext cx="69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Box 81"/>
            <p:cNvSpPr/>
            <p:nvPr/>
          </p:nvSpPr>
          <p:spPr>
            <a:xfrm>
              <a:off x="1315440" y="71280"/>
              <a:ext cx="573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R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81"/>
            <p:cNvSpPr/>
            <p:nvPr/>
          </p:nvSpPr>
          <p:spPr>
            <a:xfrm>
              <a:off x="1987560" y="72720"/>
              <a:ext cx="57312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201960" rIns="201960" tIns="100800" bIns="100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66800"/>
                  <a:tab algn="l" pos="1533600"/>
                  <a:tab algn="l" pos="2300400"/>
                  <a:tab algn="l" pos="3067200"/>
                  <a:tab algn="l" pos="3833640"/>
                  <a:tab algn="l" pos="4600440"/>
                  <a:tab algn="l" pos="5367240"/>
                  <a:tab algn="l" pos="6134040"/>
                  <a:tab algn="l" pos="6900840"/>
                  <a:tab algn="l" pos="7667640"/>
                  <a:tab algn="l" pos="8434440"/>
                  <a:tab algn="l" pos="9201240"/>
                  <a:tab algn="l" pos="9968040"/>
                  <a:tab algn="l" pos="1073484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r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30T03:56:12Z</dcterms:created>
  <dc:creator> </dc:creator>
  <dc:description/>
  <dc:language>en-US</dc:language>
  <cp:lastModifiedBy>JiaHui</cp:lastModifiedBy>
  <dcterms:modified xsi:type="dcterms:W3CDTF">2011-03-19T09:29:14Z</dcterms:modified>
  <cp:revision>19</cp:revision>
  <dc:subject/>
  <dc:title>Slide 1</dc:title>
</cp:coreProperties>
</file>